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0" d="100"/>
          <a:sy n="80" d="100"/>
        </p:scale>
        <p:origin x="6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7798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304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103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7099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2829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1654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0468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551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57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9283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552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8421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0CECCE0D-130B-4D79-97F8-BC119032B6FA}"/>
              </a:ext>
            </a:extLst>
          </p:cNvPr>
          <p:cNvSpPr txBox="1"/>
          <p:nvPr/>
        </p:nvSpPr>
        <p:spPr>
          <a:xfrm>
            <a:off x="273974" y="507419"/>
            <a:ext cx="6033838" cy="9766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processed S2 Fig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ignal detection was performed as described in the Material and methods section of the accompanying manuscript. Red rectangles indicate the cropped images shown in the respective manuscript figures. 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2" descr="A picture containing text, fabric, design, pattern&#10;&#10;Description automatically generated">
            <a:extLst>
              <a:ext uri="{FF2B5EF4-FFF2-40B4-BE49-F238E27FC236}">
                <a16:creationId xmlns:a16="http://schemas.microsoft.com/office/drawing/2014/main" id="{BFE88E51-9BB7-42E3-A817-8BD0B8483419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832" y="1892166"/>
            <a:ext cx="5935980" cy="362712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530327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34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allois Jean-Luc</dc:creator>
  <cp:lastModifiedBy>Gallois Jean-Luc</cp:lastModifiedBy>
  <cp:revision>2</cp:revision>
  <dcterms:created xsi:type="dcterms:W3CDTF">2023-09-11T13:58:36Z</dcterms:created>
  <dcterms:modified xsi:type="dcterms:W3CDTF">2023-09-11T14:02:19Z</dcterms:modified>
</cp:coreProperties>
</file>